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omments/comment1.xml" ContentType="application/vnd.openxmlformats-officedocument.presentationml.comments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60" r:id="rId5"/>
    <p:sldId id="26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ou, Yuetan (LLU)" initials="DY(" lastIdx="1" clrIdx="0">
    <p:extLst>
      <p:ext uri="{19B8F6BF-5375-455C-9EA6-DF929625EA0E}">
        <p15:presenceInfo xmlns:p15="http://schemas.microsoft.com/office/powerpoint/2012/main" userId="Dou, Yuetan (LLU)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53" d="100"/>
          <a:sy n="53" d="100"/>
        </p:scale>
        <p:origin x="52" y="2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rah Bangs" userId="6fb07f77-98d1-4375-a3b4-daada7c83d40" providerId="ADAL" clId="{70A7359C-D5F0-4D36-B25A-E76F5FDD0D0E}"/>
    <pc:docChg chg="addSld delSld modSld sldOrd">
      <pc:chgData name="Sarah Bangs" userId="6fb07f77-98d1-4375-a3b4-daada7c83d40" providerId="ADAL" clId="{70A7359C-D5F0-4D36-B25A-E76F5FDD0D0E}" dt="2019-05-28T17:14:19.270" v="113" actId="20577"/>
      <pc:docMkLst>
        <pc:docMk/>
      </pc:docMkLst>
      <pc:sldChg chg="del">
        <pc:chgData name="Sarah Bangs" userId="6fb07f77-98d1-4375-a3b4-daada7c83d40" providerId="ADAL" clId="{70A7359C-D5F0-4D36-B25A-E76F5FDD0D0E}" dt="2019-05-28T17:04:10.240" v="0" actId="2696"/>
        <pc:sldMkLst>
          <pc:docMk/>
          <pc:sldMk cId="1222324047" sldId="258"/>
        </pc:sldMkLst>
      </pc:sldChg>
      <pc:sldChg chg="add del ord">
        <pc:chgData name="Sarah Bangs" userId="6fb07f77-98d1-4375-a3b4-daada7c83d40" providerId="ADAL" clId="{70A7359C-D5F0-4D36-B25A-E76F5FDD0D0E}" dt="2019-05-28T17:10:16.808" v="10" actId="2696"/>
        <pc:sldMkLst>
          <pc:docMk/>
          <pc:sldMk cId="2857108291" sldId="258"/>
        </pc:sldMkLst>
      </pc:sldChg>
      <pc:sldChg chg="modSp add">
        <pc:chgData name="Sarah Bangs" userId="6fb07f77-98d1-4375-a3b4-daada7c83d40" providerId="ADAL" clId="{70A7359C-D5F0-4D36-B25A-E76F5FDD0D0E}" dt="2019-05-28T17:14:07.809" v="111" actId="20577"/>
        <pc:sldMkLst>
          <pc:docMk/>
          <pc:sldMk cId="1222324047" sldId="259"/>
        </pc:sldMkLst>
        <pc:spChg chg="mod">
          <ac:chgData name="Sarah Bangs" userId="6fb07f77-98d1-4375-a3b4-daada7c83d40" providerId="ADAL" clId="{70A7359C-D5F0-4D36-B25A-E76F5FDD0D0E}" dt="2019-05-28T17:14:07.809" v="111" actId="20577"/>
          <ac:spMkLst>
            <pc:docMk/>
            <pc:sldMk cId="1222324047" sldId="259"/>
            <ac:spMk id="2" creationId="{00000000-0000-0000-0000-000000000000}"/>
          </ac:spMkLst>
        </pc:spChg>
      </pc:sldChg>
      <pc:sldChg chg="modSp add">
        <pc:chgData name="Sarah Bangs" userId="6fb07f77-98d1-4375-a3b4-daada7c83d40" providerId="ADAL" clId="{70A7359C-D5F0-4D36-B25A-E76F5FDD0D0E}" dt="2019-05-28T17:14:19.270" v="113" actId="20577"/>
        <pc:sldMkLst>
          <pc:docMk/>
          <pc:sldMk cId="3326508327" sldId="260"/>
        </pc:sldMkLst>
        <pc:spChg chg="mod">
          <ac:chgData name="Sarah Bangs" userId="6fb07f77-98d1-4375-a3b4-daada7c83d40" providerId="ADAL" clId="{70A7359C-D5F0-4D36-B25A-E76F5FDD0D0E}" dt="2019-05-28T17:14:19.270" v="113" actId="20577"/>
          <ac:spMkLst>
            <pc:docMk/>
            <pc:sldMk cId="3326508327" sldId="260"/>
            <ac:spMk id="12" creationId="{00000000-0000-0000-0000-000000000000}"/>
          </ac:spMkLst>
        </pc:spChg>
      </pc:sldChg>
      <pc:sldChg chg="modSp add ord">
        <pc:chgData name="Sarah Bangs" userId="6fb07f77-98d1-4375-a3b4-daada7c83d40" providerId="ADAL" clId="{70A7359C-D5F0-4D36-B25A-E76F5FDD0D0E}" dt="2019-05-28T17:13:20.320" v="109" actId="20577"/>
        <pc:sldMkLst>
          <pc:docMk/>
          <pc:sldMk cId="3968255745" sldId="261"/>
        </pc:sldMkLst>
        <pc:spChg chg="mod">
          <ac:chgData name="Sarah Bangs" userId="6fb07f77-98d1-4375-a3b4-daada7c83d40" providerId="ADAL" clId="{70A7359C-D5F0-4D36-B25A-E76F5FDD0D0E}" dt="2019-05-28T17:13:20.320" v="109" actId="20577"/>
          <ac:spMkLst>
            <pc:docMk/>
            <pc:sldMk cId="3968255745" sldId="261"/>
            <ac:spMk id="3" creationId="{00000000-0000-0000-0000-000000000000}"/>
          </ac:spMkLst>
        </pc:spChg>
      </pc:sldChg>
    </pc:docChg>
  </pc:docChgLst>
</pc:chgInfo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18-11-27T17:25:01.080" idx="1">
    <p:pos x="10" y="10"/>
    <p:text/>
    <p:extLst>
      <p:ext uri="{C676402C-5697-4E1C-873F-D02D1690AC5C}">
        <p15:threadingInfo xmlns:p15="http://schemas.microsoft.com/office/powerpoint/2012/main" timeZoneBias="480"/>
      </p:ext>
    </p:extLst>
  </p:cm>
</p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A08DFE-625A-4B18-9D94-7312EA7F9668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3C000-A8EE-4BC9-A10D-F8A1CA25B0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3151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A08DFE-625A-4B18-9D94-7312EA7F9668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3C000-A8EE-4BC9-A10D-F8A1CA25B0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64499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A08DFE-625A-4B18-9D94-7312EA7F9668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3C000-A8EE-4BC9-A10D-F8A1CA25B0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25093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A08DFE-625A-4B18-9D94-7312EA7F9668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3C000-A8EE-4BC9-A10D-F8A1CA25B0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30830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A08DFE-625A-4B18-9D94-7312EA7F9668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3C000-A8EE-4BC9-A10D-F8A1CA25B0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0637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A08DFE-625A-4B18-9D94-7312EA7F9668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3C000-A8EE-4BC9-A10D-F8A1CA25B0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127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A08DFE-625A-4B18-9D94-7312EA7F9668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3C000-A8EE-4BC9-A10D-F8A1CA25B0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6921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A08DFE-625A-4B18-9D94-7312EA7F9668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3C000-A8EE-4BC9-A10D-F8A1CA25B0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76583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A08DFE-625A-4B18-9D94-7312EA7F9668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3C000-A8EE-4BC9-A10D-F8A1CA25B0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3140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A08DFE-625A-4B18-9D94-7312EA7F9668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3C000-A8EE-4BC9-A10D-F8A1CA25B0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29286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A08DFE-625A-4B18-9D94-7312EA7F9668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3C000-A8EE-4BC9-A10D-F8A1CA25B0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42296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A08DFE-625A-4B18-9D94-7312EA7F9668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53C000-A8EE-4BC9-A10D-F8A1CA25B0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11652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omments" Target="../comments/comment1.xml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487189" y="4889962"/>
            <a:ext cx="29136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figure 4D. Glycoprotein staining</a:t>
            </a:r>
          </a:p>
        </p:txBody>
      </p:sp>
      <p:grpSp>
        <p:nvGrpSpPr>
          <p:cNvPr id="15" name="Group 14"/>
          <p:cNvGrpSpPr/>
          <p:nvPr/>
        </p:nvGrpSpPr>
        <p:grpSpPr>
          <a:xfrm>
            <a:off x="2834640" y="1283144"/>
            <a:ext cx="3832167" cy="3422908"/>
            <a:chOff x="2834640" y="1283144"/>
            <a:chExt cx="3832167" cy="3422908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34640" y="1626121"/>
              <a:ext cx="3740727" cy="3079931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2926080" y="1283144"/>
              <a:ext cx="37407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1         2         3         4         5         6         7         8        </a:t>
              </a:r>
            </a:p>
          </p:txBody>
        </p:sp>
      </p:grpSp>
      <p:sp>
        <p:nvSpPr>
          <p:cNvPr id="11" name="TextBox 10"/>
          <p:cNvSpPr txBox="1"/>
          <p:nvPr/>
        </p:nvSpPr>
        <p:spPr>
          <a:xfrm>
            <a:off x="7232074" y="2381256"/>
            <a:ext cx="429768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 Protein ladder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, Negative control for glycoprotein staining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, Positive control for glycoprotein staining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, Galactosyltransferase reaction, complete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, Galactosyltransferase reaction, incomplete (no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VimF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VimF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, W83 cell lysate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, FLL95 cell lysate</a:t>
            </a:r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3840480" y="1560143"/>
            <a:ext cx="0" cy="585064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223408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273136" y="5573684"/>
            <a:ext cx="41625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figure 4E. Western-blot by using anti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VimF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tibody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7489767" y="2553006"/>
            <a:ext cx="365759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 Protein ladder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, W83 cell lysate de-glycosylated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, FLL95 cell lysate de-glycosylated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, ATCC33277 cell lysate de-glycosylated 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, W83 cell lysate NOT de-glycosylated 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, FLL95 cell lysate NOT de-glycosylated 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, ATCC33277 cell lysate NOT de-glycosylated </a:t>
            </a:r>
          </a:p>
        </p:txBody>
      </p:sp>
      <p:grpSp>
        <p:nvGrpSpPr>
          <p:cNvPr id="10" name="Group 9"/>
          <p:cNvGrpSpPr/>
          <p:nvPr/>
        </p:nvGrpSpPr>
        <p:grpSpPr>
          <a:xfrm>
            <a:off x="2763154" y="1123546"/>
            <a:ext cx="4444806" cy="4103081"/>
            <a:chOff x="2763154" y="1123546"/>
            <a:chExt cx="4444806" cy="4103081"/>
          </a:xfrm>
        </p:grpSpPr>
        <p:sp>
          <p:nvSpPr>
            <p:cNvPr id="4" name="TextBox 3"/>
            <p:cNvSpPr txBox="1"/>
            <p:nvPr/>
          </p:nvSpPr>
          <p:spPr>
            <a:xfrm>
              <a:off x="3919450" y="1123546"/>
              <a:ext cx="22776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      2      3      4      5      6      7</a:t>
              </a:r>
            </a:p>
          </p:txBody>
        </p:sp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686" t="29697" r="13586" b="10303"/>
            <a:stretch/>
          </p:blipFill>
          <p:spPr>
            <a:xfrm>
              <a:off x="2763154" y="1795549"/>
              <a:ext cx="4444806" cy="3431078"/>
            </a:xfrm>
            <a:prstGeom prst="rect">
              <a:avLst/>
            </a:prstGeom>
          </p:spPr>
        </p:pic>
        <p:cxnSp>
          <p:nvCxnSpPr>
            <p:cNvPr id="7" name="Straight Arrow Connector 6"/>
            <p:cNvCxnSpPr/>
            <p:nvPr/>
          </p:nvCxnSpPr>
          <p:spPr>
            <a:xfrm>
              <a:off x="4418214" y="1562793"/>
              <a:ext cx="0" cy="465512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Arrow Connector 7"/>
            <p:cNvCxnSpPr/>
            <p:nvPr/>
          </p:nvCxnSpPr>
          <p:spPr>
            <a:xfrm>
              <a:off x="5273040" y="1562793"/>
              <a:ext cx="0" cy="465512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357686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170910" y="4646816"/>
            <a:ext cx="3532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figure 8B. Galactosyltransferase assay.</a:t>
            </a:r>
          </a:p>
          <a:p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,6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ladder</a:t>
            </a:r>
          </a:p>
        </p:txBody>
      </p:sp>
      <p:graphicFrame>
        <p:nvGraphicFramePr>
          <p:cNvPr id="10" name="Table 9"/>
          <p:cNvGraphicFramePr>
            <a:graphicFrameLocks noGrp="1"/>
          </p:cNvGraphicFramePr>
          <p:nvPr>
            <p:extLst/>
          </p:nvPr>
        </p:nvGraphicFramePr>
        <p:xfrm>
          <a:off x="1995055" y="5231047"/>
          <a:ext cx="7137400" cy="1316355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2250374">
                  <a:extLst>
                    <a:ext uri="{9D8B030D-6E8A-4147-A177-3AD203B41FA5}">
                      <a16:colId xmlns:a16="http://schemas.microsoft.com/office/drawing/2014/main" val="895592262"/>
                    </a:ext>
                  </a:extLst>
                </a:gridCol>
                <a:gridCol w="619826">
                  <a:extLst>
                    <a:ext uri="{9D8B030D-6E8A-4147-A177-3AD203B41FA5}">
                      <a16:colId xmlns:a16="http://schemas.microsoft.com/office/drawing/2014/main" val="264502707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719826382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48081986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80670227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51386987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577933556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969937725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682460552"/>
                    </a:ext>
                  </a:extLst>
                </a:gridCol>
              </a:tblGrid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ne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2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3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5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429709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FLL95 extracellular fractio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-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-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4749988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FLL95 extracellular fraction precipitated by 80% ammonium sulfat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9570370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Enzyme-rVimF lysat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-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9838851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E. coli Top10 cell lysat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-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7749048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UDP-Galactos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-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01997263"/>
                  </a:ext>
                </a:extLst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49629" y="739833"/>
            <a:ext cx="263513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Figure 8b.</a:t>
            </a:r>
          </a:p>
          <a:p>
            <a:endParaRPr lang="en-US" sz="1400" dirty="0"/>
          </a:p>
          <a:p>
            <a:r>
              <a:rPr lang="en-US" sz="1400" dirty="0"/>
              <a:t>Lane 1 and 2 of Fig. 8b were taken from lane 2 and 3 of this gel</a:t>
            </a:r>
          </a:p>
        </p:txBody>
      </p:sp>
      <p:grpSp>
        <p:nvGrpSpPr>
          <p:cNvPr id="13" name="Group 12"/>
          <p:cNvGrpSpPr/>
          <p:nvPr/>
        </p:nvGrpSpPr>
        <p:grpSpPr>
          <a:xfrm>
            <a:off x="3042151" y="229395"/>
            <a:ext cx="5043207" cy="4182390"/>
            <a:chOff x="3042151" y="229395"/>
            <a:chExt cx="5043207" cy="4182390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99" t="20909" r="11769" b="19394"/>
            <a:stretch/>
          </p:blipFill>
          <p:spPr>
            <a:xfrm>
              <a:off x="3042151" y="799013"/>
              <a:ext cx="5043207" cy="3612772"/>
            </a:xfrm>
            <a:prstGeom prst="rect">
              <a:avLst/>
            </a:prstGeom>
          </p:spPr>
        </p:pic>
        <p:cxnSp>
          <p:nvCxnSpPr>
            <p:cNvPr id="4" name="Straight Arrow Connector 3"/>
            <p:cNvCxnSpPr/>
            <p:nvPr/>
          </p:nvCxnSpPr>
          <p:spPr>
            <a:xfrm flipH="1">
              <a:off x="3770564" y="253515"/>
              <a:ext cx="24937" cy="340822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Arrow Connector 8"/>
            <p:cNvCxnSpPr/>
            <p:nvPr/>
          </p:nvCxnSpPr>
          <p:spPr>
            <a:xfrm flipH="1">
              <a:off x="4107362" y="229395"/>
              <a:ext cx="60868" cy="389061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/>
            <p:cNvSpPr txBox="1"/>
            <p:nvPr/>
          </p:nvSpPr>
          <p:spPr>
            <a:xfrm>
              <a:off x="3300580" y="546133"/>
              <a:ext cx="34958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      2       3       4       5       6       7       8       9       10</a:t>
              </a:r>
            </a:p>
          </p:txBody>
        </p:sp>
      </p:grpSp>
      <p:pic>
        <p:nvPicPr>
          <p:cNvPr id="14" name="Picture 1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7859435" y="1056917"/>
            <a:ext cx="4302285" cy="32267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23240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658774" y="4444151"/>
            <a:ext cx="3532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figure 8B repeat. Galactosyltransferase assay.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: Protein ladder</a:t>
            </a: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/>
          </p:nvPr>
        </p:nvGraphicFramePr>
        <p:xfrm>
          <a:off x="2080115" y="4927891"/>
          <a:ext cx="7137397" cy="1693545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791374">
                  <a:extLst>
                    <a:ext uri="{9D8B030D-6E8A-4147-A177-3AD203B41FA5}">
                      <a16:colId xmlns:a16="http://schemas.microsoft.com/office/drawing/2014/main" val="895592262"/>
                    </a:ext>
                  </a:extLst>
                </a:gridCol>
                <a:gridCol w="493403">
                  <a:extLst>
                    <a:ext uri="{9D8B030D-6E8A-4147-A177-3AD203B41FA5}">
                      <a16:colId xmlns:a16="http://schemas.microsoft.com/office/drawing/2014/main" val="2645027071"/>
                    </a:ext>
                  </a:extLst>
                </a:gridCol>
                <a:gridCol w="485262">
                  <a:extLst>
                    <a:ext uri="{9D8B030D-6E8A-4147-A177-3AD203B41FA5}">
                      <a16:colId xmlns:a16="http://schemas.microsoft.com/office/drawing/2014/main" val="2719826382"/>
                    </a:ext>
                  </a:extLst>
                </a:gridCol>
                <a:gridCol w="485262">
                  <a:extLst>
                    <a:ext uri="{9D8B030D-6E8A-4147-A177-3AD203B41FA5}">
                      <a16:colId xmlns:a16="http://schemas.microsoft.com/office/drawing/2014/main" val="3480819861"/>
                    </a:ext>
                  </a:extLst>
                </a:gridCol>
                <a:gridCol w="485262">
                  <a:extLst>
                    <a:ext uri="{9D8B030D-6E8A-4147-A177-3AD203B41FA5}">
                      <a16:colId xmlns:a16="http://schemas.microsoft.com/office/drawing/2014/main" val="2806702271"/>
                    </a:ext>
                  </a:extLst>
                </a:gridCol>
                <a:gridCol w="485262">
                  <a:extLst>
                    <a:ext uri="{9D8B030D-6E8A-4147-A177-3AD203B41FA5}">
                      <a16:colId xmlns:a16="http://schemas.microsoft.com/office/drawing/2014/main" val="51386987"/>
                    </a:ext>
                  </a:extLst>
                </a:gridCol>
                <a:gridCol w="485262">
                  <a:extLst>
                    <a:ext uri="{9D8B030D-6E8A-4147-A177-3AD203B41FA5}">
                      <a16:colId xmlns:a16="http://schemas.microsoft.com/office/drawing/2014/main" val="577933556"/>
                    </a:ext>
                  </a:extLst>
                </a:gridCol>
                <a:gridCol w="485262">
                  <a:extLst>
                    <a:ext uri="{9D8B030D-6E8A-4147-A177-3AD203B41FA5}">
                      <a16:colId xmlns:a16="http://schemas.microsoft.com/office/drawing/2014/main" val="3969937725"/>
                    </a:ext>
                  </a:extLst>
                </a:gridCol>
                <a:gridCol w="485262">
                  <a:extLst>
                    <a:ext uri="{9D8B030D-6E8A-4147-A177-3AD203B41FA5}">
                      <a16:colId xmlns:a16="http://schemas.microsoft.com/office/drawing/2014/main" val="3682460552"/>
                    </a:ext>
                  </a:extLst>
                </a:gridCol>
                <a:gridCol w="485262">
                  <a:extLst>
                    <a:ext uri="{9D8B030D-6E8A-4147-A177-3AD203B41FA5}">
                      <a16:colId xmlns:a16="http://schemas.microsoft.com/office/drawing/2014/main" val="407014401"/>
                    </a:ext>
                  </a:extLst>
                </a:gridCol>
                <a:gridCol w="485262">
                  <a:extLst>
                    <a:ext uri="{9D8B030D-6E8A-4147-A177-3AD203B41FA5}">
                      <a16:colId xmlns:a16="http://schemas.microsoft.com/office/drawing/2014/main" val="2666303600"/>
                    </a:ext>
                  </a:extLst>
                </a:gridCol>
                <a:gridCol w="485262">
                  <a:extLst>
                    <a:ext uri="{9D8B030D-6E8A-4147-A177-3AD203B41FA5}">
                      <a16:colId xmlns:a16="http://schemas.microsoft.com/office/drawing/2014/main" val="2815889694"/>
                    </a:ext>
                  </a:extLst>
                </a:gridCol>
              </a:tblGrid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ne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6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7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4297093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83 supernatant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+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+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+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+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9981849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FLL95 extracellular fractio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-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-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-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+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4749988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FLL95 extracellular fraction precipitated by 80% ammonium sulfat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-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-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-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+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9570370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Enzyme-rVimF lysat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-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-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+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9838851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E. coli Top10 cell lysat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-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-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7749048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UDP-Galactos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dk1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dk1"/>
                          </a:solidFill>
                          <a:effectLst/>
                          <a:latin typeface="+mn-lt"/>
                        </a:rPr>
                        <a:t>-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01997263"/>
                  </a:ext>
                </a:extLst>
              </a:tr>
            </a:tbl>
          </a:graphicData>
        </a:graphic>
      </p:graphicFrame>
      <p:grpSp>
        <p:nvGrpSpPr>
          <p:cNvPr id="7" name="Group 6"/>
          <p:cNvGrpSpPr/>
          <p:nvPr/>
        </p:nvGrpSpPr>
        <p:grpSpPr>
          <a:xfrm>
            <a:off x="2334578" y="476322"/>
            <a:ext cx="4336015" cy="3759072"/>
            <a:chOff x="4005436" y="430155"/>
            <a:chExt cx="4336015" cy="3759072"/>
          </a:xfrm>
        </p:grpSpPr>
        <p:grpSp>
          <p:nvGrpSpPr>
            <p:cNvPr id="4" name="Group 3"/>
            <p:cNvGrpSpPr/>
            <p:nvPr/>
          </p:nvGrpSpPr>
          <p:grpSpPr>
            <a:xfrm>
              <a:off x="4005436" y="667960"/>
              <a:ext cx="4336015" cy="3521267"/>
              <a:chOff x="3984171" y="1242119"/>
              <a:chExt cx="4336015" cy="3521267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984171" y="1519118"/>
                <a:ext cx="4336015" cy="3244268"/>
              </a:xfrm>
              <a:prstGeom prst="rect">
                <a:avLst/>
              </a:prstGeom>
            </p:spPr>
          </p:pic>
          <p:sp>
            <p:nvSpPr>
              <p:cNvPr id="3" name="TextBox 2"/>
              <p:cNvSpPr txBox="1"/>
              <p:nvPr/>
            </p:nvSpPr>
            <p:spPr>
              <a:xfrm>
                <a:off x="4478699" y="1242119"/>
                <a:ext cx="349581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   2   3   4    5    6    7    8   9  10  11  12</a:t>
                </a:r>
              </a:p>
            </p:txBody>
          </p:sp>
        </p:grpSp>
        <p:cxnSp>
          <p:nvCxnSpPr>
            <p:cNvPr id="8" name="Straight Arrow Connector 7"/>
            <p:cNvCxnSpPr/>
            <p:nvPr/>
          </p:nvCxnSpPr>
          <p:spPr>
            <a:xfrm flipH="1">
              <a:off x="5868785" y="440575"/>
              <a:ext cx="24939" cy="29094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Arrow Connector 9"/>
            <p:cNvCxnSpPr/>
            <p:nvPr/>
          </p:nvCxnSpPr>
          <p:spPr>
            <a:xfrm flipH="1">
              <a:off x="6932281" y="430155"/>
              <a:ext cx="24939" cy="29094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1" name="Picture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7401181" y="1265571"/>
            <a:ext cx="3632662" cy="2724497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99753" y="991126"/>
            <a:ext cx="1845425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8b.</a:t>
            </a:r>
          </a:p>
          <a:p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nes 3 and 4 of Fig. 8b were taken from lanes 7 and 12 from the attached original gel. </a:t>
            </a:r>
          </a:p>
          <a:p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265083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4250" y="0"/>
            <a:ext cx="5143500" cy="6858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82633" y="1762298"/>
            <a:ext cx="3059083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licate experiment for Figure 4D:</a:t>
            </a:r>
          </a:p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is is another repeat original gel for glycoprotein stain. Lane 3 = NC, Lane 2 = PC, Lane 12 =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VimF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682557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6</TotalTime>
  <Words>382</Words>
  <Application>Microsoft Office PowerPoint</Application>
  <PresentationFormat>Widescreen</PresentationFormat>
  <Paragraphs>172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LL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u, Yuetan (LLU)</dc:creator>
  <cp:lastModifiedBy>Sarah Bangs</cp:lastModifiedBy>
  <cp:revision>17</cp:revision>
  <dcterms:created xsi:type="dcterms:W3CDTF">2018-10-05T18:25:29Z</dcterms:created>
  <dcterms:modified xsi:type="dcterms:W3CDTF">2019-05-28T17:14:38Z</dcterms:modified>
</cp:coreProperties>
</file>